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DA" initials="pm" lastIdx="3" clrIdx="0"/>
  <p:cmAuthor id="1" name="Valentina" initials="V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71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73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209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518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083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061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787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650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806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34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802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177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D62CC-A943-4E8C-B09C-E56B8CE45A6B}" type="datetimeFigureOut">
              <a:rPr lang="en-US" smtClean="0"/>
              <a:pPr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2210A-4C8B-43D8-921C-31700D00CF9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511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2754138"/>
              </p:ext>
            </p:extLst>
          </p:nvPr>
        </p:nvGraphicFramePr>
        <p:xfrm>
          <a:off x="3937000" y="3416300"/>
          <a:ext cx="2803525" cy="194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Prism 6" r:id="rId3" imgW="4322349" imgH="2831171" progId="Prism6.Document">
                  <p:embed/>
                </p:oleObj>
              </mc:Choice>
              <mc:Fallback>
                <p:oleObj name="Prism 6" r:id="rId3" imgW="4322349" imgH="283117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37000" y="3416300"/>
                        <a:ext cx="2803525" cy="1949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Rectangle 37"/>
          <p:cNvSpPr/>
          <p:nvPr/>
        </p:nvSpPr>
        <p:spPr>
          <a:xfrm>
            <a:off x="227936" y="35496"/>
            <a:ext cx="640212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16632" y="8851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692696" y="1944424"/>
            <a:ext cx="1949925" cy="524858"/>
            <a:chOff x="908720" y="1033179"/>
            <a:chExt cx="1949925" cy="524858"/>
          </a:xfrm>
        </p:grpSpPr>
        <p:pic>
          <p:nvPicPr>
            <p:cNvPr id="15" name="Picture 10"/>
            <p:cNvPicPr>
              <a:picLocks noChangeAspect="1" noChangeArrowheads="1"/>
            </p:cNvPicPr>
            <p:nvPr/>
          </p:nvPicPr>
          <p:blipFill rotWithShape="1">
            <a:blip r:embed="rId5" cstate="print">
              <a:lum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94" t="39948" r="23386" b="10894"/>
            <a:stretch/>
          </p:blipFill>
          <p:spPr bwMode="auto">
            <a:xfrm rot="5400000">
              <a:off x="1243586" y="698313"/>
              <a:ext cx="524857" cy="11945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10"/>
            <p:cNvPicPr>
              <a:picLocks noChangeAspect="1" noChangeArrowheads="1"/>
            </p:cNvPicPr>
            <p:nvPr/>
          </p:nvPicPr>
          <p:blipFill rotWithShape="1">
            <a:blip r:embed="rId5" cstate="print">
              <a:lum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94" r="23385" b="67583"/>
            <a:stretch/>
          </p:blipFill>
          <p:spPr bwMode="auto">
            <a:xfrm rot="5400000">
              <a:off x="2202326" y="901717"/>
              <a:ext cx="524858" cy="78778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34" name="TextBox 33"/>
          <p:cNvSpPr txBox="1"/>
          <p:nvPr/>
        </p:nvSpPr>
        <p:spPr>
          <a:xfrm>
            <a:off x="286816" y="2159885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x36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86816" y="192979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rot="16200000">
            <a:off x="425896" y="1497831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la Cn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 rot="16200000">
            <a:off x="756213" y="1514988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IN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 rot="16200000">
            <a:off x="967150" y="1501623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#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16200000">
            <a:off x="1226607" y="1501623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#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 rot="16200000">
            <a:off x="1436157" y="1501623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#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6200000">
            <a:off x="1682944" y="1493885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P #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6200000">
            <a:off x="1904300" y="1493885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P #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6200000">
            <a:off x="2129849" y="1493885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P #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01008" y="8851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3703458" y="1950970"/>
            <a:ext cx="2413202" cy="518312"/>
            <a:chOff x="3487109" y="987926"/>
            <a:chExt cx="2536639" cy="518312"/>
          </a:xfrm>
        </p:grpSpPr>
        <p:grpSp>
          <p:nvGrpSpPr>
            <p:cNvPr id="17" name="Group 16"/>
            <p:cNvGrpSpPr/>
            <p:nvPr/>
          </p:nvGrpSpPr>
          <p:grpSpPr>
            <a:xfrm>
              <a:off x="3899200" y="987926"/>
              <a:ext cx="2124548" cy="518312"/>
              <a:chOff x="781962" y="5333685"/>
              <a:chExt cx="2124548" cy="518312"/>
            </a:xfrm>
          </p:grpSpPr>
          <p:pic>
            <p:nvPicPr>
              <p:cNvPr id="18" name="Picture 11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lum contrast="2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44" t="1054" r="51070" b="42889"/>
              <a:stretch/>
            </p:blipFill>
            <p:spPr bwMode="auto">
              <a:xfrm rot="16200000">
                <a:off x="1178678" y="4936969"/>
                <a:ext cx="518311" cy="13117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11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lum contrast="2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36" t="64809" r="51078"/>
              <a:stretch/>
            </p:blipFill>
            <p:spPr bwMode="auto">
              <a:xfrm rot="16200000">
                <a:off x="2235618" y="5181105"/>
                <a:ext cx="518312" cy="82347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36" name="TextBox 35"/>
            <p:cNvSpPr txBox="1"/>
            <p:nvPr/>
          </p:nvSpPr>
          <p:spPr>
            <a:xfrm>
              <a:off x="3487109" y="1218018"/>
              <a:ext cx="4839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36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487109" y="987926"/>
              <a:ext cx="4974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6" name="TextBox 95"/>
          <p:cNvSpPr txBox="1"/>
          <p:nvPr/>
        </p:nvSpPr>
        <p:spPr>
          <a:xfrm rot="16200000">
            <a:off x="3879821" y="1488134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la Cn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6200000">
            <a:off x="4210138" y="1484927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IN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196752" y="885106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otal Cx36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375319" y="885106"/>
            <a:ext cx="14398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mbranous Cx36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4415852" y="1536756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#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4675309" y="1536756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#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4894384" y="1536756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#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5154185" y="1529018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P #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5381357" y="1529018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P #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5626176" y="1529018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P #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4294334"/>
              </p:ext>
            </p:extLst>
          </p:nvPr>
        </p:nvGraphicFramePr>
        <p:xfrm>
          <a:off x="350838" y="3419475"/>
          <a:ext cx="2914650" cy="1927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6" r:id="rId7" imgW="4287056" imgH="2831171" progId="Prism6.Document">
                  <p:embed/>
                </p:oleObj>
              </mc:Choice>
              <mc:Fallback>
                <p:oleObj name="Prism 6" r:id="rId7" imgW="4287056" imgH="283117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0838" y="3419475"/>
                        <a:ext cx="2914650" cy="1927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TextBox 49"/>
          <p:cNvSpPr txBox="1"/>
          <p:nvPr/>
        </p:nvSpPr>
        <p:spPr>
          <a:xfrm>
            <a:off x="116632" y="29013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501008" y="295312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80294" y="4139952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522276" y="3988788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802969" y="3714065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081088" y="3932537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358740" y="3884734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625557" y="3563160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914941" y="3812997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790159" y="450437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104178" y="4010349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§</a:t>
            </a:r>
          </a:p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164849" y="3468345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§</a:t>
            </a:r>
          </a:p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639326" y="3552412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§</a:t>
            </a:r>
          </a:p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357706" y="4004366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§</a:t>
            </a:r>
          </a:p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867273" y="3842937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§§</a:t>
            </a:r>
          </a:p>
          <a:p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389617" y="3545274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921249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8</TotalTime>
  <Words>82</Words>
  <Application>Microsoft Office PowerPoint</Application>
  <PresentationFormat>On-screen Show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GraphPad Prism 6 Project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37</cp:revision>
  <dcterms:created xsi:type="dcterms:W3CDTF">2014-06-03T10:05:07Z</dcterms:created>
  <dcterms:modified xsi:type="dcterms:W3CDTF">2015-11-15T13:51:32Z</dcterms:modified>
</cp:coreProperties>
</file>